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65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C75DA-876C-9814-7DE4-179093D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5BA292-FE38-AEFF-D734-A5DE75EE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41F4E-8D10-0C49-A11F-F8BB6ACDF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0E3A5-A250-A72D-0655-868102841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E4995-1A25-5613-3CB7-F8F1FBCA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658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3C7E-249C-C608-C640-68C35A1FF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A180C-B2AB-BFA0-1DD2-C57FFCE6D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53947-AF88-AD42-11FB-5027FC77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1670A-E8BF-FBE7-B76E-6AAB0061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F002-18E4-F467-0691-217B8C11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92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9086AB-956A-6EF1-5DBB-DC43E5DBA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7BCA-4ADA-1998-0E0E-F5021CC4F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48976-69F8-ED46-0B5C-F590C0710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4A30-63B2-A4DD-4502-3B1DDB582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8DD4B-AD6E-9022-46A0-57067D69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8981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398-2E91-DCCA-7A89-1D84D1378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CC001-5649-AB4E-6494-ACD12990FE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8D962-9ED6-6567-7417-E76244A7F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149EF-7CD2-8C65-7EEB-76B4D83A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8CDEF-2DDF-E3D9-3B5E-61A639C60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420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82F80-993F-D2FB-0DBA-485FD4D8F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A2D8-14C2-C746-3B1D-933005CAF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437D5-A396-81BA-47E0-EEEFE0AF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855B5-4FF2-A87D-2D42-1C91F9C5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100FB-51DD-A3CD-2E67-524D38891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3098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8DD7-A945-C1E3-815F-26FD23C19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54B4C6-90E7-8E99-6217-194852FC0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2E0C6-144D-ECB8-72A3-2748FD7AE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3D97D-D2D0-176E-562F-6CFEEC3F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ABEDC-26DF-E91A-B279-A0E42BB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0BB212-CE38-9BFC-1BEE-003AE576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84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06D5F-0CE7-3109-267A-DDE0F6EE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CE52BF-CBF4-9A79-43C2-00FD8F604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D3AA0-6116-EEB4-2ADD-46D16E7A9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A17345-989F-CAFF-E538-29AECBE2AE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AA2BB-06A9-515E-E6D7-40B6761B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4B79C1-3F57-F46E-C41E-754344EB6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21308-54ED-803A-630E-076B9A42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443E-6521-6B03-E4A5-0DF282F47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9904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E944-4B0A-DBE3-1026-336F0EA6D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9B25A-F645-7109-DFD8-8A3E209DC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639BA-8140-AFE8-E84A-5AE1DB01F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5D4F7E-18F3-E380-29A4-A761E131A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3873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ECAAC5-A8F4-D635-2AF1-B6AF071C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E0357-85EC-A8C4-13EE-E9DF67E4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465C70-5E4A-37F7-0442-2A0CBD8EE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61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85375-7F61-062D-AB1C-DF9C5654B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3E477-406E-C5F5-4B78-E5E53C0548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7B9FAC-3F01-D384-6DA5-DF78FA169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65789E-63D7-54B7-0C33-A70C241B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7737B-EC50-0FEF-DA55-B81A8B1A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94EC0-CEAE-21D8-8AE5-5B165533C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3747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A9F-C6F0-792B-050C-29C4DFDFD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E15C31-1847-8321-3FB3-09E6B813D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766E6-64D7-4E38-1599-707BD73E3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E8DF5-E161-B255-0C7B-9FABBF9C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7C65-43FA-49B8-125B-AC7F7FA25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17EA60-AE12-BB00-E775-17EE0201D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228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1378DE-852B-CFB7-9A7A-083536627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828B3-FE3D-3926-B625-63B9F59B6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7AED3-ED14-68E6-52DD-3E815FF5F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B404-05E3-EF5C-F3ED-A45358ABC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35E14-3BAD-3053-0D55-C41CCC65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6167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6C9E952-2A1E-40CE-9CE3-A542371F1B5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72" t="41898" r="-22" b="13967"/>
          <a:stretch/>
        </p:blipFill>
        <p:spPr bwMode="auto">
          <a:xfrm>
            <a:off x="4359964" y="3014870"/>
            <a:ext cx="4151971" cy="2749826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1C6C533-77BB-4EF7-B0E3-7F32D66EB951}"/>
              </a:ext>
            </a:extLst>
          </p:cNvPr>
          <p:cNvSpPr/>
          <p:nvPr/>
        </p:nvSpPr>
        <p:spPr>
          <a:xfrm>
            <a:off x="4585298" y="3701326"/>
            <a:ext cx="2844001" cy="68578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7C5EA60-26AD-468B-9347-5D50AAE15D1B}"/>
              </a:ext>
            </a:extLst>
          </p:cNvPr>
          <p:cNvSpPr txBox="1"/>
          <p:nvPr/>
        </p:nvSpPr>
        <p:spPr>
          <a:xfrm>
            <a:off x="7817003" y="3701326"/>
            <a:ext cx="1120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3227D58-9BD0-4F4A-AC3C-40ACE0FECD22}"/>
              </a:ext>
            </a:extLst>
          </p:cNvPr>
          <p:cNvSpPr txBox="1"/>
          <p:nvPr/>
        </p:nvSpPr>
        <p:spPr>
          <a:xfrm>
            <a:off x="7846743" y="4106478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438D938-5344-ED38-B68E-DD1B0D7EC3D2}"/>
              </a:ext>
            </a:extLst>
          </p:cNvPr>
          <p:cNvSpPr txBox="1"/>
          <p:nvPr/>
        </p:nvSpPr>
        <p:spPr>
          <a:xfrm rot="16200000">
            <a:off x="4639955" y="2765178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A7133E-0BC7-D529-F615-37F58B7D9E0C}"/>
              </a:ext>
            </a:extLst>
          </p:cNvPr>
          <p:cNvSpPr txBox="1"/>
          <p:nvPr/>
        </p:nvSpPr>
        <p:spPr>
          <a:xfrm rot="16200000">
            <a:off x="5277612" y="1555440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FC574F-D4F3-3971-B10D-D455EB23CC7F}"/>
              </a:ext>
            </a:extLst>
          </p:cNvPr>
          <p:cNvSpPr txBox="1"/>
          <p:nvPr/>
        </p:nvSpPr>
        <p:spPr>
          <a:xfrm rot="16200000">
            <a:off x="4818072" y="2476557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1CC9E0-DE0C-3026-FC9F-422CC2302441}"/>
              </a:ext>
            </a:extLst>
          </p:cNvPr>
          <p:cNvSpPr txBox="1"/>
          <p:nvPr/>
        </p:nvSpPr>
        <p:spPr>
          <a:xfrm rot="16200000">
            <a:off x="5577361" y="2356183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3B153AA-D751-CF21-AACD-CC131E33F18E}"/>
              </a:ext>
            </a:extLst>
          </p:cNvPr>
          <p:cNvSpPr txBox="1"/>
          <p:nvPr/>
        </p:nvSpPr>
        <p:spPr>
          <a:xfrm rot="16200000">
            <a:off x="5295750" y="2529307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EB7D12-D80D-82DE-D259-93637B70C00D}"/>
              </a:ext>
            </a:extLst>
          </p:cNvPr>
          <p:cNvSpPr txBox="1"/>
          <p:nvPr/>
        </p:nvSpPr>
        <p:spPr>
          <a:xfrm rot="16200000">
            <a:off x="5738458" y="1601697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38B42EA-0BC3-F659-8540-C6BF64E770E1}"/>
              </a:ext>
            </a:extLst>
          </p:cNvPr>
          <p:cNvCxnSpPr>
            <a:cxnSpLocks/>
          </p:cNvCxnSpPr>
          <p:nvPr/>
        </p:nvCxnSpPr>
        <p:spPr>
          <a:xfrm>
            <a:off x="4660648" y="310919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E6D0605-6A8F-1171-E605-0CA937DB0FC3}"/>
              </a:ext>
            </a:extLst>
          </p:cNvPr>
          <p:cNvCxnSpPr>
            <a:cxnSpLocks/>
          </p:cNvCxnSpPr>
          <p:nvPr/>
        </p:nvCxnSpPr>
        <p:spPr>
          <a:xfrm>
            <a:off x="5124474" y="310919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8490E10-96E9-AB98-88AD-218211A88608}"/>
              </a:ext>
            </a:extLst>
          </p:cNvPr>
          <p:cNvCxnSpPr>
            <a:cxnSpLocks/>
          </p:cNvCxnSpPr>
          <p:nvPr/>
        </p:nvCxnSpPr>
        <p:spPr>
          <a:xfrm>
            <a:off x="5585319" y="31089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C354C21-5E47-D5B6-9E43-A9BACF8B6574}"/>
              </a:ext>
            </a:extLst>
          </p:cNvPr>
          <p:cNvCxnSpPr>
            <a:cxnSpLocks/>
          </p:cNvCxnSpPr>
          <p:nvPr/>
        </p:nvCxnSpPr>
        <p:spPr>
          <a:xfrm>
            <a:off x="6039799" y="31089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A6EC852-9CB8-5632-5558-0269BE98C6E5}"/>
              </a:ext>
            </a:extLst>
          </p:cNvPr>
          <p:cNvCxnSpPr>
            <a:cxnSpLocks/>
          </p:cNvCxnSpPr>
          <p:nvPr/>
        </p:nvCxnSpPr>
        <p:spPr>
          <a:xfrm>
            <a:off x="6489448" y="3111357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09365F5-686F-B939-14FA-A8FB9D581937}"/>
              </a:ext>
            </a:extLst>
          </p:cNvPr>
          <p:cNvCxnSpPr>
            <a:cxnSpLocks/>
          </p:cNvCxnSpPr>
          <p:nvPr/>
        </p:nvCxnSpPr>
        <p:spPr>
          <a:xfrm>
            <a:off x="6946648" y="31089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561643BC-7B59-6EE6-9536-962B2DBC2BB8}"/>
              </a:ext>
            </a:extLst>
          </p:cNvPr>
          <p:cNvSpPr txBox="1"/>
          <p:nvPr/>
        </p:nvSpPr>
        <p:spPr>
          <a:xfrm>
            <a:off x="4070408" y="314486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9976CC3-E2E4-5459-00C2-FDF404573CF0}"/>
              </a:ext>
            </a:extLst>
          </p:cNvPr>
          <p:cNvSpPr txBox="1"/>
          <p:nvPr/>
        </p:nvSpPr>
        <p:spPr>
          <a:xfrm>
            <a:off x="3689603" y="3424327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274040A-AC43-3952-1EC3-B9E447506529}"/>
              </a:ext>
            </a:extLst>
          </p:cNvPr>
          <p:cNvSpPr txBox="1"/>
          <p:nvPr/>
        </p:nvSpPr>
        <p:spPr>
          <a:xfrm>
            <a:off x="4596043" y="3128134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9316A0-6103-4617-04E6-392FF3F19EB6}"/>
              </a:ext>
            </a:extLst>
          </p:cNvPr>
          <p:cNvSpPr txBox="1"/>
          <p:nvPr/>
        </p:nvSpPr>
        <p:spPr>
          <a:xfrm>
            <a:off x="4596043" y="3377520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E42E5CC-7FBA-6F96-0DAD-270E09A5F28C}"/>
              </a:ext>
            </a:extLst>
          </p:cNvPr>
          <p:cNvSpPr txBox="1"/>
          <p:nvPr/>
        </p:nvSpPr>
        <p:spPr>
          <a:xfrm>
            <a:off x="1014222" y="102502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BF34FA7-192D-401A-9787-46B59A9B98DD}"/>
              </a:ext>
            </a:extLst>
          </p:cNvPr>
          <p:cNvCxnSpPr>
            <a:cxnSpLocks/>
          </p:cNvCxnSpPr>
          <p:nvPr/>
        </p:nvCxnSpPr>
        <p:spPr>
          <a:xfrm>
            <a:off x="4223593" y="457393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36">
            <a:extLst>
              <a:ext uri="{FF2B5EF4-FFF2-40B4-BE49-F238E27FC236}">
                <a16:creationId xmlns:a16="http://schemas.microsoft.com/office/drawing/2014/main" id="{015C0B8D-58E3-4DE6-BF19-454CE4EFE6F3}"/>
              </a:ext>
            </a:extLst>
          </p:cNvPr>
          <p:cNvSpPr txBox="1"/>
          <p:nvPr/>
        </p:nvSpPr>
        <p:spPr>
          <a:xfrm>
            <a:off x="3895207" y="44318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48850D4-1A6F-4202-BA77-74E331369C68}"/>
              </a:ext>
            </a:extLst>
          </p:cNvPr>
          <p:cNvCxnSpPr>
            <a:cxnSpLocks/>
          </p:cNvCxnSpPr>
          <p:nvPr/>
        </p:nvCxnSpPr>
        <p:spPr>
          <a:xfrm>
            <a:off x="4223593" y="479697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38">
            <a:extLst>
              <a:ext uri="{FF2B5EF4-FFF2-40B4-BE49-F238E27FC236}">
                <a16:creationId xmlns:a16="http://schemas.microsoft.com/office/drawing/2014/main" id="{17857408-0151-4A47-A829-79D29D6676A7}"/>
              </a:ext>
            </a:extLst>
          </p:cNvPr>
          <p:cNvSpPr txBox="1"/>
          <p:nvPr/>
        </p:nvSpPr>
        <p:spPr>
          <a:xfrm>
            <a:off x="3895207" y="465490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10E8EB3-7ABC-44AF-817B-43C42A7602A7}"/>
              </a:ext>
            </a:extLst>
          </p:cNvPr>
          <p:cNvCxnSpPr>
            <a:cxnSpLocks/>
          </p:cNvCxnSpPr>
          <p:nvPr/>
        </p:nvCxnSpPr>
        <p:spPr>
          <a:xfrm>
            <a:off x="4229729" y="421601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40">
            <a:extLst>
              <a:ext uri="{FF2B5EF4-FFF2-40B4-BE49-F238E27FC236}">
                <a16:creationId xmlns:a16="http://schemas.microsoft.com/office/drawing/2014/main" id="{4FBBD120-0B82-462B-A1A0-ADED2852B0B5}"/>
              </a:ext>
            </a:extLst>
          </p:cNvPr>
          <p:cNvSpPr txBox="1"/>
          <p:nvPr/>
        </p:nvSpPr>
        <p:spPr>
          <a:xfrm>
            <a:off x="3901343" y="40739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58655F5B-6626-43D2-B335-371BEE968A8D}"/>
              </a:ext>
            </a:extLst>
          </p:cNvPr>
          <p:cNvCxnSpPr>
            <a:cxnSpLocks/>
          </p:cNvCxnSpPr>
          <p:nvPr/>
        </p:nvCxnSpPr>
        <p:spPr>
          <a:xfrm>
            <a:off x="4223593" y="401121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42">
            <a:extLst>
              <a:ext uri="{FF2B5EF4-FFF2-40B4-BE49-F238E27FC236}">
                <a16:creationId xmlns:a16="http://schemas.microsoft.com/office/drawing/2014/main" id="{914F6FFB-42E7-41F6-B136-B2A94CF3501B}"/>
              </a:ext>
            </a:extLst>
          </p:cNvPr>
          <p:cNvSpPr txBox="1"/>
          <p:nvPr/>
        </p:nvSpPr>
        <p:spPr>
          <a:xfrm>
            <a:off x="3895207" y="38623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4DC44C71-8904-48A6-BFEC-21720B43FB9B}"/>
              </a:ext>
            </a:extLst>
          </p:cNvPr>
          <p:cNvCxnSpPr>
            <a:cxnSpLocks/>
          </p:cNvCxnSpPr>
          <p:nvPr/>
        </p:nvCxnSpPr>
        <p:spPr>
          <a:xfrm>
            <a:off x="4223593" y="389697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42">
            <a:extLst>
              <a:ext uri="{FF2B5EF4-FFF2-40B4-BE49-F238E27FC236}">
                <a16:creationId xmlns:a16="http://schemas.microsoft.com/office/drawing/2014/main" id="{2CA58868-248F-4A84-8F93-6A902DF23820}"/>
              </a:ext>
            </a:extLst>
          </p:cNvPr>
          <p:cNvSpPr txBox="1"/>
          <p:nvPr/>
        </p:nvSpPr>
        <p:spPr>
          <a:xfrm>
            <a:off x="3810247" y="372947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910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4</cp:revision>
  <dcterms:created xsi:type="dcterms:W3CDTF">2024-08-13T14:15:55Z</dcterms:created>
  <dcterms:modified xsi:type="dcterms:W3CDTF">2024-08-14T21:55:11Z</dcterms:modified>
</cp:coreProperties>
</file>